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66" d="100"/>
          <a:sy n="66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FD845A-CF3F-98E8-57D7-1AD8354E48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37C1954-61A1-3248-4B35-68BA6C344F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0B119-FB17-F09D-28AD-B117B3B57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E54687-7296-3E11-E20A-3549B3531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5925EE-3092-0C0A-E3A6-0C2F29258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723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ACF5D5-1E14-323A-0003-B3D4720FC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F1DD5C-5698-7CAE-6947-6BA237BB13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48419C-73E2-278D-6A99-A166114DB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9BD012-CD49-012E-67F8-446D8AAC6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73F5CA-30C9-4E33-7336-F1024740D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1585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D22481-523F-B1FC-B393-D43D7334E8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3B2B3B-BB8B-2BA8-0E90-5FC728F913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09C642-B347-8E82-C5EA-AA96C72D4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B108B-DFF1-26D0-1A3D-ADCFBC635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667F67-7296-91F7-D575-B3C59DA04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744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4CB861-D9C6-9C96-DA2D-E6951A02F9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816163-9DBD-19AD-7556-56A1843AD1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3ED0DA-E644-7507-9C7D-4B5B270AE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2F379B-CA6E-4DF0-D613-0EF2BC76C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E28BAC-0E04-736F-243A-770EC1A45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5845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7CF658-0EBF-7DB2-1B45-2218E970A4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43F47D-16DE-AB92-9F00-85276216D0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122DFF-3410-39AB-66AD-40AF22395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69FBAB-7037-7616-F812-827A1138B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F27B3-32B4-22CB-EF83-1D1B8FD0E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017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CE1262-C1AC-D958-AD82-ABB6BAEDE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62FAEA-FFE3-DD6B-FCEA-845C4373FF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228AEB-8226-6D45-E5F4-E832003E1F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C33139-1FE4-F17A-C480-2901EA6ED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7D0838-765F-87CA-A805-82341D4477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A2DA7E-095D-4E5B-4D0A-D686DCFDD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29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409EE-D22B-1A7A-470B-F645FE0166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D532DF-928A-ECDF-88A4-D98A46E656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D11648-5A01-74A6-FEEC-3F1D63726D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211B11-7DA9-2552-8B51-44067B9A24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C4C31D5-888C-0DF0-AA02-49BD5968E1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444288-34DD-E0EB-2D82-E435D509B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3C139A-5E21-E50C-340C-6AEE8D3CB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8C71C0-8AB1-A1E6-8A1C-700C9503B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381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14A338-425B-4F8B-AEF5-5262746346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1BF216-8EC5-48C8-27BF-328A5978A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EE06CD-1F07-0841-5C44-68D5A5169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747118A-0BD6-2F92-3551-6E673E0BF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8202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CC3C06-173E-DDE0-BC93-68C4CF37D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BB1DBC-E2BA-8C5E-2EC7-4515141AD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5C3A18-5F31-F178-40B8-2C3D5F5B9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6057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AAF05-50AD-CD15-A6BF-C200E56B7B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4F0845-A7B9-588F-0691-9DABD36FA9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B36DA3-D2D9-A535-8B40-F0C5384850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CEA423-2D03-301F-0585-C7EBC21D2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4F3B4C-4B36-450F-7A07-FD2778E3B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6DC65D-526E-460B-AB8F-B229398F6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0395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F5C50-19C3-CC07-0F7E-4404AD8B30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9D0DF5-D15D-F1E2-0286-6FE88F9994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544E9B-85F7-FF67-F6D1-427B35AABF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D86BFC-F4A1-4E74-AF2C-CF96BD0E9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A78D21-5D32-6754-807B-CE9C46C23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D21BAC-9259-3240-65F3-3BB4D6713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9730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AFA8CB-C68C-84A6-3E85-D53DD85B0F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9D2E56-36E5-553D-0ADC-2951D9E6B0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74C7DE-8101-0DD8-6A18-3F12E98AA6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A546F-6320-5249-9B82-A04149DE8C3E}" type="datetimeFigureOut">
              <a:rPr lang="en-GB" smtClean="0"/>
              <a:t>28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182850-E149-A8AD-1F90-192074E319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4B2084-736C-E3A2-5218-C3443ABC48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A06B2-3B7F-FB4E-8686-9302A03AF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42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A77FC37-0711-EA87-3AFE-449135C2F7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7801" y="981766"/>
            <a:ext cx="5853154" cy="4335670"/>
          </a:xfrm>
          <a:prstGeom prst="rect">
            <a:avLst/>
          </a:prstGeom>
        </p:spPr>
      </p:pic>
      <p:sp>
        <p:nvSpPr>
          <p:cNvPr id="5" name="Frame 4">
            <a:extLst>
              <a:ext uri="{FF2B5EF4-FFF2-40B4-BE49-F238E27FC236}">
                <a16:creationId xmlns:a16="http://schemas.microsoft.com/office/drawing/2014/main" id="{2F9312F9-98D3-1FD9-8AB0-A7F19BA1046C}"/>
              </a:ext>
            </a:extLst>
          </p:cNvPr>
          <p:cNvSpPr/>
          <p:nvPr/>
        </p:nvSpPr>
        <p:spPr>
          <a:xfrm>
            <a:off x="7553734" y="3766931"/>
            <a:ext cx="725556" cy="496957"/>
          </a:xfrm>
          <a:prstGeom prst="fram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6" name="Frame 5">
            <a:extLst>
              <a:ext uri="{FF2B5EF4-FFF2-40B4-BE49-F238E27FC236}">
                <a16:creationId xmlns:a16="http://schemas.microsoft.com/office/drawing/2014/main" id="{61BD28EF-BF0F-509F-0C38-9DB4ECB1EB8B}"/>
              </a:ext>
            </a:extLst>
          </p:cNvPr>
          <p:cNvSpPr/>
          <p:nvPr/>
        </p:nvSpPr>
        <p:spPr>
          <a:xfrm>
            <a:off x="9167186" y="3766930"/>
            <a:ext cx="725556" cy="496957"/>
          </a:xfrm>
          <a:prstGeom prst="fram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7" name="Frame 6">
            <a:extLst>
              <a:ext uri="{FF2B5EF4-FFF2-40B4-BE49-F238E27FC236}">
                <a16:creationId xmlns:a16="http://schemas.microsoft.com/office/drawing/2014/main" id="{0C4A14CA-E3C1-61F7-01E6-6F0DCEA220D1}"/>
              </a:ext>
            </a:extLst>
          </p:cNvPr>
          <p:cNvSpPr/>
          <p:nvPr/>
        </p:nvSpPr>
        <p:spPr>
          <a:xfrm>
            <a:off x="10280866" y="3690731"/>
            <a:ext cx="725556" cy="496957"/>
          </a:xfrm>
          <a:prstGeom prst="fram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1A1443-9F4F-113E-30FF-4F69BF85EF17}"/>
              </a:ext>
            </a:extLst>
          </p:cNvPr>
          <p:cNvSpPr txBox="1"/>
          <p:nvPr/>
        </p:nvSpPr>
        <p:spPr>
          <a:xfrm>
            <a:off x="7583551" y="5347878"/>
            <a:ext cx="628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Oct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293D145-D985-37B8-0512-FAC7517CECC2}"/>
              </a:ext>
            </a:extLst>
          </p:cNvPr>
          <p:cNvSpPr txBox="1"/>
          <p:nvPr/>
        </p:nvSpPr>
        <p:spPr>
          <a:xfrm>
            <a:off x="9196443" y="5347878"/>
            <a:ext cx="667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tat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FE1D8B-11F0-DCB0-3F52-0CC2B7DFEE5E}"/>
              </a:ext>
            </a:extLst>
          </p:cNvPr>
          <p:cNvSpPr txBox="1"/>
          <p:nvPr/>
        </p:nvSpPr>
        <p:spPr>
          <a:xfrm>
            <a:off x="10427531" y="5317436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-acti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540815D-EED4-942E-5CB5-371E4176C3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434" y="981766"/>
            <a:ext cx="5853153" cy="4335669"/>
          </a:xfrm>
          <a:prstGeom prst="rect">
            <a:avLst/>
          </a:prstGeom>
        </p:spPr>
      </p:pic>
      <p:sp>
        <p:nvSpPr>
          <p:cNvPr id="12" name="Frame 11">
            <a:extLst>
              <a:ext uri="{FF2B5EF4-FFF2-40B4-BE49-F238E27FC236}">
                <a16:creationId xmlns:a16="http://schemas.microsoft.com/office/drawing/2014/main" id="{814C348D-7394-4149-0EF1-3E3BD351373D}"/>
              </a:ext>
            </a:extLst>
          </p:cNvPr>
          <p:cNvSpPr/>
          <p:nvPr/>
        </p:nvSpPr>
        <p:spPr>
          <a:xfrm>
            <a:off x="3412430" y="4167810"/>
            <a:ext cx="725556" cy="496957"/>
          </a:xfrm>
          <a:prstGeom prst="frame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070A04E-8D56-450B-0AE8-A75AC0EAB996}"/>
              </a:ext>
            </a:extLst>
          </p:cNvPr>
          <p:cNvSpPr txBox="1"/>
          <p:nvPr/>
        </p:nvSpPr>
        <p:spPr>
          <a:xfrm>
            <a:off x="3376701" y="5347878"/>
            <a:ext cx="797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ano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A284B8-2AD9-9C90-BBFC-BC69E5F7D6C3}"/>
              </a:ext>
            </a:extLst>
          </p:cNvPr>
          <p:cNvSpPr txBox="1"/>
          <p:nvPr/>
        </p:nvSpPr>
        <p:spPr>
          <a:xfrm>
            <a:off x="105434" y="612434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el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A005035-55C4-3933-CD13-B676AC7647EC}"/>
              </a:ext>
            </a:extLst>
          </p:cNvPr>
          <p:cNvSpPr txBox="1"/>
          <p:nvPr/>
        </p:nvSpPr>
        <p:spPr>
          <a:xfrm>
            <a:off x="6096000" y="581992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el 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CFE3358-B1D7-4141-C095-4FCB3515DF85}"/>
              </a:ext>
            </a:extLst>
          </p:cNvPr>
          <p:cNvSpPr txBox="1"/>
          <p:nvPr/>
        </p:nvSpPr>
        <p:spPr>
          <a:xfrm>
            <a:off x="178904" y="268357"/>
            <a:ext cx="5878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1F – RT PCR analysis of Nanog, Oct4, Stat3 and B-act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5008411-2A0A-DA13-0963-075CD8EBAFF7}"/>
              </a:ext>
            </a:extLst>
          </p:cNvPr>
          <p:cNvSpPr txBox="1"/>
          <p:nvPr/>
        </p:nvSpPr>
        <p:spPr>
          <a:xfrm>
            <a:off x="178904" y="5864091"/>
            <a:ext cx="1180205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Gels were loaded from left to right: KTOSA 1 CD34-; KTOSA1 CD34+; KTOSA4 CD34-; KTOSA4 CD34+; KTOSA5 CD34-; KTOSA5 CD34+; Negative control. And incubated with primers (left to right) against </a:t>
            </a:r>
            <a:r>
              <a:rPr lang="en-GB" sz="1400" dirty="0" err="1"/>
              <a:t>cTERT</a:t>
            </a:r>
            <a:r>
              <a:rPr lang="en-GB" sz="1400" dirty="0"/>
              <a:t>; Nanog, B-actin; Oct4; Stat3; and B-actin. Please note that four B-actin samples are loaded on Gel 1 and two KTOSA5 samples and negative control loaded on Gel 2. Please also note that there was a loading error in the Stat3 samples and samples are loaded in the following order: KTOSA 1 CD34-; KTOSA1 CD34+; KTOSA4 CD34-; KTOSA5 CD34-; KTOSA5 CD34+; KTOSA4 CD34+.     </a:t>
            </a:r>
          </a:p>
        </p:txBody>
      </p:sp>
    </p:spTree>
    <p:extLst>
      <p:ext uri="{BB962C8B-B14F-4D97-AF65-F5344CB8AC3E}">
        <p14:creationId xmlns:p14="http://schemas.microsoft.com/office/powerpoint/2010/main" val="4291658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Pang</dc:creator>
  <cp:lastModifiedBy>Maria Zalm</cp:lastModifiedBy>
  <cp:revision>6</cp:revision>
  <dcterms:created xsi:type="dcterms:W3CDTF">2023-10-23T11:10:50Z</dcterms:created>
  <dcterms:modified xsi:type="dcterms:W3CDTF">2024-06-28T17:51:42Z</dcterms:modified>
</cp:coreProperties>
</file>